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91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70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02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54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99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50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810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8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57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76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97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8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24.jpe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12" Type="http://schemas.openxmlformats.org/officeDocument/2006/relationships/image" Target="../media/image23.jpeg"/><Relationship Id="rId17" Type="http://schemas.openxmlformats.org/officeDocument/2006/relationships/image" Target="../media/image28.jpeg"/><Relationship Id="rId2" Type="http://schemas.openxmlformats.org/officeDocument/2006/relationships/image" Target="../media/image14.jpeg"/><Relationship Id="rId16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jpeg"/><Relationship Id="rId11" Type="http://schemas.openxmlformats.org/officeDocument/2006/relationships/image" Target="../media/image22.jpeg"/><Relationship Id="rId5" Type="http://schemas.openxmlformats.org/officeDocument/2006/relationships/image" Target="../media/image17.jpeg"/><Relationship Id="rId15" Type="http://schemas.openxmlformats.org/officeDocument/2006/relationships/image" Target="../media/image26.jpeg"/><Relationship Id="rId10" Type="http://schemas.openxmlformats.org/officeDocument/2006/relationships/image" Target="../media/image21.jpeg"/><Relationship Id="rId4" Type="http://schemas.openxmlformats.org/officeDocument/2006/relationships/image" Target="../media/image16.jpeg"/><Relationship Id="rId9" Type="http://schemas.openxmlformats.org/officeDocument/2006/relationships/image" Target="../media/image20.jpeg"/><Relationship Id="rId14" Type="http://schemas.openxmlformats.org/officeDocument/2006/relationships/image" Target="../media/image25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12" Type="http://schemas.openxmlformats.org/officeDocument/2006/relationships/image" Target="../media/image39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jpeg"/><Relationship Id="rId11" Type="http://schemas.openxmlformats.org/officeDocument/2006/relationships/image" Target="../media/image38.jpeg"/><Relationship Id="rId5" Type="http://schemas.openxmlformats.org/officeDocument/2006/relationships/image" Target="../media/image32.jpeg"/><Relationship Id="rId10" Type="http://schemas.openxmlformats.org/officeDocument/2006/relationships/image" Target="../media/image37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그림 8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1" t="29240" r="11156" b="25244"/>
          <a:stretch/>
        </p:blipFill>
        <p:spPr>
          <a:xfrm>
            <a:off x="8895775" y="1359049"/>
            <a:ext cx="1732589" cy="910774"/>
          </a:xfrm>
          <a:prstGeom prst="rect">
            <a:avLst/>
          </a:prstGeom>
          <a:ln>
            <a:noFill/>
          </a:ln>
        </p:spPr>
      </p:pic>
      <p:pic>
        <p:nvPicPr>
          <p:cNvPr id="93" name="그림 9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52" t="17908" r="12814" b="36175"/>
          <a:stretch/>
        </p:blipFill>
        <p:spPr>
          <a:xfrm>
            <a:off x="4104441" y="4623597"/>
            <a:ext cx="1718545" cy="1146406"/>
          </a:xfrm>
          <a:prstGeom prst="rect">
            <a:avLst/>
          </a:prstGeom>
        </p:spPr>
      </p:pic>
      <p:pic>
        <p:nvPicPr>
          <p:cNvPr id="91" name="그림 90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45" t="45195" r="7160" b="7619"/>
          <a:stretch/>
        </p:blipFill>
        <p:spPr>
          <a:xfrm>
            <a:off x="6597411" y="4819439"/>
            <a:ext cx="1483342" cy="939940"/>
          </a:xfrm>
          <a:prstGeom prst="rect">
            <a:avLst/>
          </a:prstGeom>
          <a:ln>
            <a:noFill/>
          </a:ln>
        </p:spPr>
      </p:pic>
      <p:pic>
        <p:nvPicPr>
          <p:cNvPr id="89" name="그림 88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78" t="28600" r="48304" b="50759"/>
          <a:stretch/>
        </p:blipFill>
        <p:spPr>
          <a:xfrm>
            <a:off x="8974417" y="3227910"/>
            <a:ext cx="1329516" cy="983689"/>
          </a:xfrm>
          <a:prstGeom prst="rect">
            <a:avLst/>
          </a:prstGeom>
          <a:ln>
            <a:noFill/>
          </a:ln>
        </p:spPr>
      </p:pic>
      <p:pic>
        <p:nvPicPr>
          <p:cNvPr id="88" name="그림 87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4" t="26565" r="12726" b="32389"/>
          <a:stretch/>
        </p:blipFill>
        <p:spPr>
          <a:xfrm>
            <a:off x="6369401" y="3287068"/>
            <a:ext cx="1744056" cy="1030167"/>
          </a:xfrm>
          <a:prstGeom prst="rect">
            <a:avLst/>
          </a:prstGeom>
          <a:ln>
            <a:noFill/>
          </a:ln>
        </p:spPr>
      </p:pic>
      <p:pic>
        <p:nvPicPr>
          <p:cNvPr id="86" name="그림 85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66" t="13325" r="39341" b="16283"/>
          <a:stretch/>
        </p:blipFill>
        <p:spPr>
          <a:xfrm>
            <a:off x="6526915" y="964259"/>
            <a:ext cx="1245506" cy="1542057"/>
          </a:xfrm>
          <a:prstGeom prst="rect">
            <a:avLst/>
          </a:prstGeom>
          <a:ln>
            <a:noFill/>
          </a:ln>
        </p:spPr>
      </p:pic>
      <p:pic>
        <p:nvPicPr>
          <p:cNvPr id="85" name="그림 8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84" t="31669" r="16153" b="24216"/>
          <a:stretch/>
        </p:blipFill>
        <p:spPr>
          <a:xfrm>
            <a:off x="4083126" y="1326906"/>
            <a:ext cx="1493877" cy="952826"/>
          </a:xfrm>
          <a:prstGeom prst="rect">
            <a:avLst/>
          </a:prstGeom>
          <a:ln>
            <a:noFill/>
          </a:ln>
        </p:spPr>
      </p:pic>
      <p:sp>
        <p:nvSpPr>
          <p:cNvPr id="32" name="TextBox 31"/>
          <p:cNvSpPr txBox="1"/>
          <p:nvPr/>
        </p:nvSpPr>
        <p:spPr>
          <a:xfrm>
            <a:off x="4050739" y="918970"/>
            <a:ext cx="11961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O-GlcNAc (RL-2</a:t>
            </a:r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오른쪽 대괄호 32"/>
          <p:cNvSpPr/>
          <p:nvPr/>
        </p:nvSpPr>
        <p:spPr>
          <a:xfrm rot="16200000">
            <a:off x="4420513" y="1107067"/>
            <a:ext cx="253007" cy="41033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6749857" y="640172"/>
            <a:ext cx="799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오른쪽 대괄호 35"/>
          <p:cNvSpPr/>
          <p:nvPr/>
        </p:nvSpPr>
        <p:spPr>
          <a:xfrm rot="16200000">
            <a:off x="6920338" y="865090"/>
            <a:ext cx="523845" cy="56645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9068896" y="1112828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오른쪽 대괄호 38"/>
          <p:cNvSpPr/>
          <p:nvPr/>
        </p:nvSpPr>
        <p:spPr>
          <a:xfrm rot="16200000">
            <a:off x="9101715" y="1379074"/>
            <a:ext cx="539683" cy="42124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13" t="30370" r="46785" b="29675"/>
          <a:stretch/>
        </p:blipFill>
        <p:spPr>
          <a:xfrm>
            <a:off x="4115603" y="3150373"/>
            <a:ext cx="1546779" cy="1187895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4662292" y="2792931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오른쪽 대괄호 41"/>
          <p:cNvSpPr/>
          <p:nvPr/>
        </p:nvSpPr>
        <p:spPr>
          <a:xfrm rot="16200000">
            <a:off x="4687540" y="2837064"/>
            <a:ext cx="366484" cy="81092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6697546" y="2813063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오른쪽 대괄호 44"/>
          <p:cNvSpPr/>
          <p:nvPr/>
        </p:nvSpPr>
        <p:spPr>
          <a:xfrm rot="16200000">
            <a:off x="6712821" y="3094247"/>
            <a:ext cx="513045" cy="44311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9389524" y="2850538"/>
            <a:ext cx="499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오른쪽 대괄호 47"/>
          <p:cNvSpPr/>
          <p:nvPr/>
        </p:nvSpPr>
        <p:spPr>
          <a:xfrm rot="16200000">
            <a:off x="9369543" y="3020167"/>
            <a:ext cx="539267" cy="66781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/>
          <p:cNvSpPr txBox="1"/>
          <p:nvPr/>
        </p:nvSpPr>
        <p:spPr>
          <a:xfrm>
            <a:off x="6830892" y="4353807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오른쪽 대괄호 52"/>
          <p:cNvSpPr/>
          <p:nvPr/>
        </p:nvSpPr>
        <p:spPr>
          <a:xfrm rot="16200000">
            <a:off x="6915045" y="4623910"/>
            <a:ext cx="411096" cy="43558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3708266" y="128111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757959" y="1641058"/>
            <a:ext cx="3593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754660" y="1555925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704968" y="1480592"/>
            <a:ext cx="4090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704967" y="1395459"/>
            <a:ext cx="4090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757958" y="1761852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6121911" y="137267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121911" y="160845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6121911" y="178739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6096474" y="115503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605251" y="1759054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8595787" y="1160743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547543" y="1607131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732712" y="3204140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733822" y="327741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733821" y="341121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121911" y="3185081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6135878" y="334435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135877" y="347815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611217" y="315747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8605252" y="346638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8605251" y="366315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742592" y="462359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729456" y="471430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729456" y="501241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229999" y="4653583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6280273" y="494511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6280273" y="5072426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4202266" y="438993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오른쪽 대괄호 122"/>
          <p:cNvSpPr/>
          <p:nvPr/>
        </p:nvSpPr>
        <p:spPr>
          <a:xfrm rot="16200000">
            <a:off x="4360196" y="4480497"/>
            <a:ext cx="214698" cy="5692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xtBox 123"/>
          <p:cNvSpPr txBox="1"/>
          <p:nvPr/>
        </p:nvSpPr>
        <p:spPr>
          <a:xfrm>
            <a:off x="0" y="0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Figure 3A</a:t>
            </a:r>
          </a:p>
          <a:p>
            <a:r>
              <a:rPr lang="en-US" altLang="ko-KR" b="1" smtClean="0"/>
              <a:t>Uncropped image</a:t>
            </a:r>
            <a:endParaRPr lang="ko-KR" altLang="en-US" b="1"/>
          </a:p>
        </p:txBody>
      </p:sp>
      <p:sp>
        <p:nvSpPr>
          <p:cNvPr id="92" name="TextBox 91"/>
          <p:cNvSpPr txBox="1"/>
          <p:nvPr/>
        </p:nvSpPr>
        <p:spPr>
          <a:xfrm>
            <a:off x="8547543" y="1446839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125" name="그림 12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99" t="41979" r="48858" b="42091"/>
          <a:stretch/>
        </p:blipFill>
        <p:spPr>
          <a:xfrm>
            <a:off x="1112254" y="2364396"/>
            <a:ext cx="986400" cy="60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6" name="그림 125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09" t="35983" r="44518" b="56074"/>
          <a:stretch/>
        </p:blipFill>
        <p:spPr>
          <a:xfrm>
            <a:off x="1112254" y="3020092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7" name="그림 126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6" t="40716" r="49888" b="52049"/>
          <a:stretch/>
        </p:blipFill>
        <p:spPr>
          <a:xfrm>
            <a:off x="1112254" y="3599481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그림 127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1" t="39050" r="52248" b="55668"/>
          <a:stretch/>
        </p:blipFill>
        <p:spPr>
          <a:xfrm>
            <a:off x="1112254" y="3888721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9" name="그림 128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81" t="37029" r="52234" b="58240"/>
          <a:stretch/>
        </p:blipFill>
        <p:spPr>
          <a:xfrm>
            <a:off x="1112254" y="4177195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0" name="그림 129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94" t="56572" r="36738" b="36218"/>
          <a:stretch/>
        </p:blipFill>
        <p:spPr>
          <a:xfrm>
            <a:off x="1112254" y="4761313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1" name="TextBox 130"/>
          <p:cNvSpPr txBox="1"/>
          <p:nvPr/>
        </p:nvSpPr>
        <p:spPr>
          <a:xfrm>
            <a:off x="625429" y="1931664"/>
            <a:ext cx="1519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-   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­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36566" y="2087071"/>
            <a:ext cx="15808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MI-1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46380" y="189302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2062785" y="2471823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2062785" y="302380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2062785" y="4178728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2062785" y="3310427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062785" y="3597051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062785" y="388367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2056373" y="448603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2062785" y="4763188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722030" y="2284089"/>
            <a:ext cx="438005" cy="69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3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732697" y="481816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778876" y="405347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778876" y="461434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778875" y="2968084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787188" y="3184264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786436" y="355868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794749" y="383296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786435" y="433729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151" name="그림 150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90" t="28372" r="47472" b="63915"/>
          <a:stretch/>
        </p:blipFill>
        <p:spPr>
          <a:xfrm>
            <a:off x="1112254" y="4471155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2" name="그림 151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58" t="56757" r="52130" b="37032"/>
          <a:stretch/>
        </p:blipFill>
        <p:spPr>
          <a:xfrm>
            <a:off x="1112254" y="3310828"/>
            <a:ext cx="986400" cy="2484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69454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9" t="27328" r="42115" b="42740"/>
          <a:stretch/>
        </p:blipFill>
        <p:spPr>
          <a:xfrm>
            <a:off x="6872684" y="4636652"/>
            <a:ext cx="1449228" cy="1203974"/>
          </a:xfrm>
          <a:prstGeom prst="rect">
            <a:avLst/>
          </a:prstGeom>
        </p:spPr>
      </p:pic>
      <p:pic>
        <p:nvPicPr>
          <p:cNvPr id="137" name="그림 136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68" t="30383" r="45589" b="31657"/>
          <a:stretch/>
        </p:blipFill>
        <p:spPr>
          <a:xfrm>
            <a:off x="7027002" y="2787777"/>
            <a:ext cx="1172781" cy="1188111"/>
          </a:xfrm>
          <a:prstGeom prst="rect">
            <a:avLst/>
          </a:prstGeom>
          <a:ln>
            <a:noFill/>
          </a:ln>
        </p:spPr>
      </p:pic>
      <p:pic>
        <p:nvPicPr>
          <p:cNvPr id="135" name="그림 13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43" t="20414" r="34429" b="34879"/>
          <a:stretch/>
        </p:blipFill>
        <p:spPr>
          <a:xfrm>
            <a:off x="9669794" y="4815594"/>
            <a:ext cx="1138608" cy="1106075"/>
          </a:xfrm>
          <a:prstGeom prst="rect">
            <a:avLst/>
          </a:prstGeom>
        </p:spPr>
      </p:pic>
      <p:pic>
        <p:nvPicPr>
          <p:cNvPr id="133" name="그림 13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26" t="26813" r="32485" b="29259"/>
          <a:stretch/>
        </p:blipFill>
        <p:spPr>
          <a:xfrm>
            <a:off x="4663389" y="4586191"/>
            <a:ext cx="1329267" cy="1346200"/>
          </a:xfrm>
          <a:prstGeom prst="rect">
            <a:avLst/>
          </a:prstGeom>
        </p:spPr>
      </p:pic>
      <p:pic>
        <p:nvPicPr>
          <p:cNvPr id="131" name="그림 13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88" t="32535" r="34698" b="34634"/>
          <a:stretch/>
        </p:blipFill>
        <p:spPr>
          <a:xfrm>
            <a:off x="4691230" y="2929981"/>
            <a:ext cx="1236134" cy="889000"/>
          </a:xfrm>
          <a:prstGeom prst="rect">
            <a:avLst/>
          </a:prstGeom>
        </p:spPr>
      </p:pic>
      <p:pic>
        <p:nvPicPr>
          <p:cNvPr id="130" name="그림 1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68" t="27100" r="29233" b="22843"/>
          <a:stretch/>
        </p:blipFill>
        <p:spPr>
          <a:xfrm>
            <a:off x="9497773" y="1165912"/>
            <a:ext cx="1151467" cy="1032934"/>
          </a:xfrm>
          <a:prstGeom prst="rect">
            <a:avLst/>
          </a:prstGeom>
        </p:spPr>
      </p:pic>
      <p:pic>
        <p:nvPicPr>
          <p:cNvPr id="129" name="그림 128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84" t="31669" r="16153" b="24216"/>
          <a:stretch/>
        </p:blipFill>
        <p:spPr>
          <a:xfrm>
            <a:off x="6850360" y="1182884"/>
            <a:ext cx="1493877" cy="952826"/>
          </a:xfrm>
          <a:prstGeom prst="rect">
            <a:avLst/>
          </a:prstGeom>
          <a:ln>
            <a:noFill/>
          </a:ln>
        </p:spPr>
      </p:pic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7" t="27294" r="6238"/>
          <a:stretch/>
        </p:blipFill>
        <p:spPr>
          <a:xfrm>
            <a:off x="4641173" y="1243233"/>
            <a:ext cx="1388533" cy="82591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7" t="17682" r="12840" b="26993"/>
          <a:stretch/>
        </p:blipFill>
        <p:spPr>
          <a:xfrm>
            <a:off x="9380516" y="2847938"/>
            <a:ext cx="2019892" cy="114686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5044991" y="770406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OGT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오른쪽 대괄호 40"/>
          <p:cNvSpPr/>
          <p:nvPr/>
        </p:nvSpPr>
        <p:spPr>
          <a:xfrm rot="16200000">
            <a:off x="5169933" y="997788"/>
            <a:ext cx="509640" cy="64361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/>
          <p:cNvSpPr txBox="1"/>
          <p:nvPr/>
        </p:nvSpPr>
        <p:spPr>
          <a:xfrm>
            <a:off x="7201209" y="726795"/>
            <a:ext cx="11961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O-GlcNAc (RL-2</a:t>
            </a:r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오른쪽 대괄호 42"/>
          <p:cNvSpPr/>
          <p:nvPr/>
        </p:nvSpPr>
        <p:spPr>
          <a:xfrm rot="16200000">
            <a:off x="7866235" y="938674"/>
            <a:ext cx="270845" cy="42145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4880599" y="2541974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오른쪽 대괄호 45"/>
          <p:cNvSpPr/>
          <p:nvPr/>
        </p:nvSpPr>
        <p:spPr>
          <a:xfrm rot="16200000">
            <a:off x="4879676" y="2813170"/>
            <a:ext cx="744375" cy="60585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7279704" y="2351581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오른쪽 대괄호 47"/>
          <p:cNvSpPr/>
          <p:nvPr/>
        </p:nvSpPr>
        <p:spPr>
          <a:xfrm rot="16200000">
            <a:off x="7349862" y="2586385"/>
            <a:ext cx="596542" cy="5892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/>
          <p:cNvSpPr txBox="1"/>
          <p:nvPr/>
        </p:nvSpPr>
        <p:spPr>
          <a:xfrm>
            <a:off x="4874988" y="4240441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오른쪽 대괄호 50"/>
          <p:cNvSpPr/>
          <p:nvPr/>
        </p:nvSpPr>
        <p:spPr>
          <a:xfrm rot="16200000">
            <a:off x="5098191" y="4338799"/>
            <a:ext cx="364457" cy="67419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7288836" y="4240441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오른쪽 대괄호 53"/>
          <p:cNvSpPr/>
          <p:nvPr/>
        </p:nvSpPr>
        <p:spPr>
          <a:xfrm rot="16200000">
            <a:off x="7425759" y="4404408"/>
            <a:ext cx="569776" cy="76118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>
            <a:off x="9721272" y="580120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오른쪽 대괄호 56"/>
          <p:cNvSpPr/>
          <p:nvPr/>
        </p:nvSpPr>
        <p:spPr>
          <a:xfrm rot="16200000">
            <a:off x="9864112" y="756254"/>
            <a:ext cx="487536" cy="57516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9669794" y="2228470"/>
            <a:ext cx="742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오른쪽 대괄호 59"/>
          <p:cNvSpPr/>
          <p:nvPr/>
        </p:nvSpPr>
        <p:spPr>
          <a:xfrm rot="16200000">
            <a:off x="9693374" y="2494460"/>
            <a:ext cx="662509" cy="61659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9936771" y="459239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오른쪽 대괄호 62"/>
          <p:cNvSpPr/>
          <p:nvPr/>
        </p:nvSpPr>
        <p:spPr>
          <a:xfrm rot="16200000">
            <a:off x="10058100" y="4740967"/>
            <a:ext cx="411096" cy="53274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/>
          <p:cNvSpPr txBox="1"/>
          <p:nvPr/>
        </p:nvSpPr>
        <p:spPr>
          <a:xfrm>
            <a:off x="4276733" y="112235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273434" y="1395471"/>
            <a:ext cx="4090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271218" y="1535478"/>
            <a:ext cx="4090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320911" y="1636882"/>
            <a:ext cx="3593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477286" y="115711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526979" y="1517056"/>
            <a:ext cx="3593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523680" y="1431923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6473988" y="1356590"/>
            <a:ext cx="4090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6473987" y="1271457"/>
            <a:ext cx="4090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6526978" y="1637850"/>
            <a:ext cx="3593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7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9001942" y="943810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000284" y="11721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9000283" y="1368966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238422" y="342257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219185" y="289898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238422" y="327884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6755071" y="306548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755071" y="330126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6755071" y="348021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6729634" y="269544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6755071" y="291308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9003693" y="2850111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9017606" y="309211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9017763" y="299685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4240025" y="463972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241135" y="47129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241134" y="484679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6502268" y="463665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6507970" y="516261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6502268" y="491100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9320692" y="485849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370966" y="515002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9370966" y="527733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0" y="0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Figure 3C</a:t>
            </a:r>
          </a:p>
          <a:p>
            <a:r>
              <a:rPr lang="en-US" altLang="ko-KR" b="1" smtClean="0"/>
              <a:t>Uncropped image</a:t>
            </a:r>
            <a:endParaRPr lang="ko-KR" altLang="en-US" b="1"/>
          </a:p>
        </p:txBody>
      </p:sp>
      <p:sp>
        <p:nvSpPr>
          <p:cNvPr id="134" name="TextBox 133"/>
          <p:cNvSpPr txBox="1"/>
          <p:nvPr/>
        </p:nvSpPr>
        <p:spPr>
          <a:xfrm>
            <a:off x="6500665" y="5332558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575222" y="1712291"/>
            <a:ext cx="1519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-   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  </a:t>
            </a:r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­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37635" y="1867698"/>
            <a:ext cx="15295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OGT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423210" y="17034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2" name="그림 141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81" t="59516" r="18785" b="24989"/>
          <a:stretch/>
        </p:blipFill>
        <p:spPr>
          <a:xfrm>
            <a:off x="1080821" y="2110601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3" name="그림 142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04" t="50859" r="16641" b="33369"/>
          <a:stretch/>
        </p:blipFill>
        <p:spPr>
          <a:xfrm>
            <a:off x="1080821" y="2393746"/>
            <a:ext cx="986400" cy="59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4" name="그림 143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30" t="54229" r="42539" b="39147"/>
          <a:stretch/>
        </p:blipFill>
        <p:spPr>
          <a:xfrm>
            <a:off x="1080821" y="3048381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5" name="그림 144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76" t="38067" r="39749" b="55803"/>
          <a:stretch/>
        </p:blipFill>
        <p:spPr>
          <a:xfrm>
            <a:off x="1080821" y="3636402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6" name="그림 145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86" t="35669" r="39112" b="58810"/>
          <a:stretch/>
        </p:blipFill>
        <p:spPr>
          <a:xfrm>
            <a:off x="1080821" y="4224685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7" name="그림 146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68" t="38363" r="41796" b="53033"/>
          <a:stretch/>
        </p:blipFill>
        <p:spPr>
          <a:xfrm>
            <a:off x="1080821" y="4783036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8" name="그림 147"/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44" t="30850" r="56478" b="61825"/>
          <a:stretch/>
        </p:blipFill>
        <p:spPr>
          <a:xfrm>
            <a:off x="1080821" y="4504503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9" name="TextBox 148"/>
          <p:cNvSpPr txBox="1"/>
          <p:nvPr/>
        </p:nvSpPr>
        <p:spPr>
          <a:xfrm>
            <a:off x="2025664" y="2454366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030881" y="2091392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025663" y="3038629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025663" y="3340275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025664" y="3628770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025663" y="391376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2025663" y="4771910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013273" y="4508250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6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2017368" y="422086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689702" y="2324823"/>
            <a:ext cx="438005" cy="69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3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689702" y="487536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693107" y="1982496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746548" y="467516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746546" y="292481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754859" y="321411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754108" y="3572986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762420" y="381379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752036" y="4118568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759599" y="438943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168" name="그림 167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98" t="41329" r="48716" b="52932"/>
          <a:stretch/>
        </p:blipFill>
        <p:spPr>
          <a:xfrm>
            <a:off x="1080821" y="3345326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0" name="그림 16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08" t="38031" r="47668" b="55338"/>
          <a:stretch/>
        </p:blipFill>
        <p:spPr>
          <a:xfrm>
            <a:off x="1080821" y="3924897"/>
            <a:ext cx="986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883388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6" name="그림 17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34" t="13420" r="36563" b="22404"/>
          <a:stretch/>
        </p:blipFill>
        <p:spPr>
          <a:xfrm>
            <a:off x="7155223" y="1026596"/>
            <a:ext cx="1597247" cy="1181525"/>
          </a:xfrm>
          <a:prstGeom prst="rect">
            <a:avLst/>
          </a:prstGeom>
          <a:ln>
            <a:noFill/>
          </a:ln>
        </p:spPr>
      </p:pic>
      <p:pic>
        <p:nvPicPr>
          <p:cNvPr id="134" name="그림 13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56" t="25813" r="31758" b="42116"/>
          <a:stretch/>
        </p:blipFill>
        <p:spPr>
          <a:xfrm>
            <a:off x="9347919" y="1074207"/>
            <a:ext cx="2021534" cy="1165252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78" t="25988" r="31545" b="39873"/>
          <a:stretch/>
        </p:blipFill>
        <p:spPr>
          <a:xfrm>
            <a:off x="5264922" y="4802549"/>
            <a:ext cx="1343837" cy="1078607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9" t="35466" r="45199" b="34408"/>
          <a:stretch/>
        </p:blipFill>
        <p:spPr>
          <a:xfrm>
            <a:off x="4776332" y="2626847"/>
            <a:ext cx="1873082" cy="1279178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65" t="26792" r="38824" b="32911"/>
          <a:stretch/>
        </p:blipFill>
        <p:spPr>
          <a:xfrm>
            <a:off x="9723000" y="2666536"/>
            <a:ext cx="1395117" cy="1324178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93" t="29860" r="24787" b="42332"/>
          <a:stretch/>
        </p:blipFill>
        <p:spPr>
          <a:xfrm>
            <a:off x="7200339" y="2949784"/>
            <a:ext cx="1642605" cy="873726"/>
          </a:xfrm>
          <a:prstGeom prst="rect">
            <a:avLst/>
          </a:prstGeom>
        </p:spPr>
      </p:pic>
      <p:pic>
        <p:nvPicPr>
          <p:cNvPr id="50" name="그림 4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64" t="30585" r="31060" b="46050"/>
          <a:stretch/>
        </p:blipFill>
        <p:spPr>
          <a:xfrm>
            <a:off x="4751206" y="1139106"/>
            <a:ext cx="1898208" cy="924516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4955925" y="683613"/>
            <a:ext cx="11961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O-GlcNAc (RL-2</a:t>
            </a:r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오른쪽 대괄호 51"/>
          <p:cNvSpPr/>
          <p:nvPr/>
        </p:nvSpPr>
        <p:spPr>
          <a:xfrm rot="16200000">
            <a:off x="5374094" y="678584"/>
            <a:ext cx="414780" cy="99920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7758120" y="775023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오른쪽 대괄호 53"/>
          <p:cNvSpPr/>
          <p:nvPr/>
        </p:nvSpPr>
        <p:spPr>
          <a:xfrm rot="16200000">
            <a:off x="7623471" y="825267"/>
            <a:ext cx="552920" cy="82199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10288382" y="627390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오른쪽 대괄호 55"/>
          <p:cNvSpPr/>
          <p:nvPr/>
        </p:nvSpPr>
        <p:spPr>
          <a:xfrm rot="16200000">
            <a:off x="10177732" y="647967"/>
            <a:ext cx="751927" cy="121574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5449438" y="2277777"/>
            <a:ext cx="4267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오른쪽 대괄호 57"/>
          <p:cNvSpPr/>
          <p:nvPr/>
        </p:nvSpPr>
        <p:spPr>
          <a:xfrm rot="16200000">
            <a:off x="5550360" y="2257390"/>
            <a:ext cx="513593" cy="104647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7716720" y="2370737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오른쪽 대괄호 59"/>
          <p:cNvSpPr/>
          <p:nvPr/>
        </p:nvSpPr>
        <p:spPr>
          <a:xfrm rot="16200000">
            <a:off x="7657886" y="2595439"/>
            <a:ext cx="615919" cy="776084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10009407" y="2460536"/>
            <a:ext cx="8146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smtClean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en-US" altLang="ko-KR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오른쪽 대괄호 61"/>
          <p:cNvSpPr/>
          <p:nvPr/>
        </p:nvSpPr>
        <p:spPr>
          <a:xfrm rot="16200000">
            <a:off x="10276504" y="2416109"/>
            <a:ext cx="295222" cy="82043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/>
          <p:cNvSpPr txBox="1"/>
          <p:nvPr/>
        </p:nvSpPr>
        <p:spPr>
          <a:xfrm>
            <a:off x="5645155" y="4213307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오른쪽 대괄호 63"/>
          <p:cNvSpPr/>
          <p:nvPr/>
        </p:nvSpPr>
        <p:spPr>
          <a:xfrm rot="16200000">
            <a:off x="5650484" y="4396065"/>
            <a:ext cx="570157" cy="72321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4304493" y="1473363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304493" y="1340360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327259" y="112511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326458" y="160136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821709" y="281518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822819" y="305713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6822818" y="3190934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820106" y="145981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789663" y="124956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822947" y="157031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9363927" y="325616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9363927" y="303789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9344522" y="273892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9363926" y="350226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9000182" y="169877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8965892" y="95633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9000182" y="152910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509073" y="258010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510183" y="282205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510182" y="295586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4878449" y="466824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928723" y="495977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928723" y="508708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0" y="0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Figure 3G</a:t>
            </a:r>
          </a:p>
          <a:p>
            <a:r>
              <a:rPr lang="en-US" altLang="ko-KR" b="1" smtClean="0"/>
              <a:t>Uncropped image</a:t>
            </a:r>
            <a:endParaRPr lang="ko-KR" altLang="en-US" b="1"/>
          </a:p>
        </p:txBody>
      </p:sp>
      <p:pic>
        <p:nvPicPr>
          <p:cNvPr id="89" name="그림 88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87" t="37155" r="41160" b="51561"/>
          <a:stretch/>
        </p:blipFill>
        <p:spPr>
          <a:xfrm>
            <a:off x="989246" y="2263136"/>
            <a:ext cx="1490400" cy="45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5" name="그림 134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55" t="45625" r="50010" b="48300"/>
          <a:stretch/>
        </p:blipFill>
        <p:spPr>
          <a:xfrm>
            <a:off x="989246" y="3261899"/>
            <a:ext cx="1490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6" name="그림 135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52" t="40008" r="43187" b="41861"/>
          <a:stretch/>
        </p:blipFill>
        <p:spPr>
          <a:xfrm>
            <a:off x="989246" y="3776541"/>
            <a:ext cx="1490400" cy="58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7" name="그림 136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56" t="32875" r="36454" b="60390"/>
          <a:stretch/>
        </p:blipFill>
        <p:spPr>
          <a:xfrm>
            <a:off x="989246" y="4393860"/>
            <a:ext cx="1490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8" name="그림 137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88" t="41281" r="35270" b="51318"/>
          <a:stretch/>
        </p:blipFill>
        <p:spPr>
          <a:xfrm>
            <a:off x="989246" y="3519220"/>
            <a:ext cx="1490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9" name="TextBox 138"/>
          <p:cNvSpPr txBox="1"/>
          <p:nvPr/>
        </p:nvSpPr>
        <p:spPr>
          <a:xfrm>
            <a:off x="145606" y="1622514"/>
            <a:ext cx="277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1046499" y="2115148"/>
            <a:ext cx="357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977168" y="1783186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ty</a:t>
            </a:r>
          </a:p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995118" y="20691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227395" y="2069181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478390" y="20691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718137" y="2069181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953650" y="206918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2192318" y="207416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529701" y="2069181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: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직선 연결선 148"/>
          <p:cNvCxnSpPr/>
          <p:nvPr/>
        </p:nvCxnSpPr>
        <p:spPr>
          <a:xfrm>
            <a:off x="1537419" y="2115147"/>
            <a:ext cx="357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1384774" y="1854853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직선 연결선 150"/>
          <p:cNvCxnSpPr/>
          <p:nvPr/>
        </p:nvCxnSpPr>
        <p:spPr>
          <a:xfrm>
            <a:off x="2021382" y="2121136"/>
            <a:ext cx="357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/>
          <p:cNvSpPr txBox="1"/>
          <p:nvPr/>
        </p:nvSpPr>
        <p:spPr>
          <a:xfrm>
            <a:off x="1916671" y="1781405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305A/</a:t>
            </a: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312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직선 연결선 152"/>
          <p:cNvCxnSpPr/>
          <p:nvPr/>
        </p:nvCxnSpPr>
        <p:spPr>
          <a:xfrm>
            <a:off x="1516320" y="1814657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1758736" y="1627420"/>
            <a:ext cx="4026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2470142" y="2734811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470142" y="2988479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2470142" y="3242151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470142" y="350453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470142" y="4381491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2470142" y="232127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O-GlcNAc</a:t>
            </a:r>
          </a:p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2470142" y="4051179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2450177" y="3772174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-Caspase-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624125" y="249405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566417" y="2358171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555040" y="2183537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623986" y="261885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623986" y="288133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623985" y="314278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623985" y="340489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623985" y="377418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623985" y="3936308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623985" y="427902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570565" y="447107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4" name="그림 17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79" t="45960" r="32719" b="47635"/>
          <a:stretch/>
        </p:blipFill>
        <p:spPr>
          <a:xfrm>
            <a:off x="994655" y="3006120"/>
            <a:ext cx="1490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그림 174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58" t="42518" r="42547" b="48199"/>
          <a:stretch/>
        </p:blipFill>
        <p:spPr>
          <a:xfrm>
            <a:off x="996663" y="2745497"/>
            <a:ext cx="1490400" cy="2232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32894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98</Words>
  <Application>Microsoft Office PowerPoint</Application>
  <PresentationFormat>와이드스크린</PresentationFormat>
  <Paragraphs>201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g-Kyun Park</cp:lastModifiedBy>
  <cp:revision>8</cp:revision>
  <dcterms:created xsi:type="dcterms:W3CDTF">2021-10-12T00:46:16Z</dcterms:created>
  <dcterms:modified xsi:type="dcterms:W3CDTF">2021-10-16T06:06:58Z</dcterms:modified>
</cp:coreProperties>
</file>